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9" r:id="rId4"/>
    <p:sldId id="260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补充图片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1440" y="2650490"/>
            <a:ext cx="12080240" cy="157162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602740" y="4523740"/>
            <a:ext cx="7412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upplementary Figure 1: schematic diagram of chromosomal copy number</a:t>
            </a:r>
            <a:endParaRPr lang="en-US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补充图片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56460" y="1068705"/>
            <a:ext cx="6904990" cy="394081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014220" y="5306695"/>
            <a:ext cx="81629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upplementary Figure 2: Schematic diagram of the Y chromosome signals by OGM</a:t>
            </a:r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补充图片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000250" y="641985"/>
            <a:ext cx="6809105" cy="475297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987675" y="5337175"/>
            <a:ext cx="5245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upplementary Figure 3: the local CNV plot of chr15</a:t>
            </a:r>
            <a:endParaRPr lang="en-US" altLang="zh-CN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5</Words>
  <Application>WPS 演示</Application>
  <PresentationFormat>宽屏</PresentationFormat>
  <Paragraphs>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邓佳</dc:creator>
  <cp:lastModifiedBy>赵东</cp:lastModifiedBy>
  <cp:revision>7</cp:revision>
  <dcterms:created xsi:type="dcterms:W3CDTF">2023-08-09T12:44:00Z</dcterms:created>
  <dcterms:modified xsi:type="dcterms:W3CDTF">2025-04-21T02:26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20305</vt:lpwstr>
  </property>
</Properties>
</file>